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76" r:id="rId3"/>
  </p:sldIdLst>
  <p:sldSz cx="9144000" cy="5720080" type="screen16x10"/>
  <p:notesSz cx="6858000" cy="9144000"/>
  <p:custDataLst>
    <p:tags r:id="rId9"/>
  </p:custData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72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이대웅" initials="이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91" autoAdjust="0"/>
  </p:normalViewPr>
  <p:slideViewPr>
    <p:cSldViewPr snapToGrid="0" showGuides="1">
      <p:cViewPr>
        <p:scale>
          <a:sx n="125" d="100"/>
          <a:sy n="125" d="100"/>
        </p:scale>
        <p:origin x="90" y="90"/>
      </p:cViewPr>
      <p:guideLst>
        <p:guide orient="horz" pos="177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F:\my%20experiment\Peanut%20salt\salt%20stress%20test\2021_hogland_peanut%20plant%20salt%20stress%20test\Admixture\CV%20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2225" cap="rnd" cmpd="sng" algn="ctr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Sheet1!$A$1:$A$15</c:f>
              <c:strCache>
                <c:ptCount val="15"/>
                <c:pt idx="0">
                  <c:v>K=1</c:v>
                </c:pt>
                <c:pt idx="1">
                  <c:v>K=2</c:v>
                </c:pt>
                <c:pt idx="2">
                  <c:v>K=3</c:v>
                </c:pt>
                <c:pt idx="3">
                  <c:v>K=4</c:v>
                </c:pt>
                <c:pt idx="4">
                  <c:v>K=5</c:v>
                </c:pt>
                <c:pt idx="5">
                  <c:v>K=6</c:v>
                </c:pt>
                <c:pt idx="6">
                  <c:v>K=7</c:v>
                </c:pt>
                <c:pt idx="7">
                  <c:v>K=8</c:v>
                </c:pt>
                <c:pt idx="8">
                  <c:v>K=9</c:v>
                </c:pt>
                <c:pt idx="9">
                  <c:v>K=10</c:v>
                </c:pt>
                <c:pt idx="10">
                  <c:v>K=11</c:v>
                </c:pt>
                <c:pt idx="11">
                  <c:v>K=12</c:v>
                </c:pt>
                <c:pt idx="12">
                  <c:v>K=13</c:v>
                </c:pt>
                <c:pt idx="13">
                  <c:v>K=14</c:v>
                </c:pt>
                <c:pt idx="14">
                  <c:v>K=15</c:v>
                </c:pt>
              </c:strCache>
            </c:strRef>
          </c:cat>
          <c:val>
            <c:numRef>
              <c:f>Sheet1!$B$1:$B$15</c:f>
              <c:numCache>
                <c:formatCode>0.000</c:formatCode>
                <c:ptCount val="15"/>
                <c:pt idx="0">
                  <c:v>0.58946</c:v>
                </c:pt>
                <c:pt idx="1">
                  <c:v>0.41824</c:v>
                </c:pt>
                <c:pt idx="2">
                  <c:v>0.31903</c:v>
                </c:pt>
                <c:pt idx="3">
                  <c:v>0.28207</c:v>
                </c:pt>
                <c:pt idx="4">
                  <c:v>0.25575</c:v>
                </c:pt>
                <c:pt idx="5">
                  <c:v>0.27159</c:v>
                </c:pt>
                <c:pt idx="6">
                  <c:v>0.24075</c:v>
                </c:pt>
                <c:pt idx="7">
                  <c:v>0.22608</c:v>
                </c:pt>
                <c:pt idx="8">
                  <c:v>0.24033</c:v>
                </c:pt>
                <c:pt idx="9">
                  <c:v>0.22516</c:v>
                </c:pt>
                <c:pt idx="10">
                  <c:v>0.24134</c:v>
                </c:pt>
                <c:pt idx="11">
                  <c:v>0.22915</c:v>
                </c:pt>
                <c:pt idx="12">
                  <c:v>0.23239</c:v>
                </c:pt>
                <c:pt idx="13">
                  <c:v>0.23432</c:v>
                </c:pt>
                <c:pt idx="14">
                  <c:v>0.23655</c:v>
                </c:pt>
              </c:numCache>
            </c:numRef>
          </c:val>
          <c:smooth val="0"/>
        </c:ser>
        <c:dLbls>
          <c:showLegendKey val="0"/>
          <c:showVal val="1"/>
          <c:showCatName val="0"/>
          <c:showSerName val="0"/>
          <c:showPercent val="0"/>
          <c:showBubbleSize val="0"/>
        </c:dLbls>
        <c:dropLines>
          <c:spPr>
            <a:ln w="9525" cap="flat" cmpd="sng" algn="ctr">
              <a:solidFill>
                <a:schemeClr val="dk1">
                  <a:lumMod val="35000"/>
                  <a:lumOff val="65000"/>
                  <a:alpha val="33000"/>
                </a:schemeClr>
              </a:solidFill>
              <a:round/>
            </a:ln>
            <a:effectLst/>
          </c:spPr>
        </c:dropLines>
        <c:marker val="0"/>
        <c:smooth val="0"/>
        <c:axId val="505356144"/>
        <c:axId val="505348656"/>
      </c:lineChart>
      <c:catAx>
        <c:axId val="505356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1" i="0" u="none" strike="noStrike" kern="1200" spc="20" baseline="0">
                <a:solidFill>
                  <a:schemeClr val="dk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505348656"/>
        <c:crosses val="autoZero"/>
        <c:auto val="1"/>
        <c:lblAlgn val="ctr"/>
        <c:lblOffset val="100"/>
        <c:noMultiLvlLbl val="0"/>
      </c:catAx>
      <c:valAx>
        <c:axId val="505348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000" b="1" i="0" u="none" strike="noStrike" kern="1200" cap="all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defRPr>
                </a:pPr>
                <a:r>
                  <a:rPr lang="en-US" sz="1000" b="1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  <a:sym typeface="Times New Roman" panose="02020603050405020304" pitchFamily="18" charset="0"/>
                  </a:rPr>
                  <a:t>CV error</a:t>
                </a:r>
                <a:endParaRPr lang="ko-KR" sz="1000" b="1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1" i="0" u="none" strike="noStrike" kern="1200" spc="20" baseline="0">
                <a:solidFill>
                  <a:schemeClr val="dk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505356144"/>
        <c:crosses val="autoZero"/>
        <c:crossBetween val="between"/>
      </c:valAx>
      <c:spPr>
        <a:gradFill>
          <a:gsLst>
            <a:gs pos="100000">
              <a:schemeClr val="lt1">
                <a:lumMod val="95000"/>
              </a:schemeClr>
            </a:gs>
            <a:gs pos="0">
              <a:schemeClr val="lt1"/>
            </a:gs>
          </a:gsLst>
          <a:lin ang="5400000" scaled="0"/>
        </a:gradFill>
        <a:ln>
          <a:noFill/>
        </a:ln>
        <a:effectLst/>
      </c:spPr>
    </c:plotArea>
    <c:plotVisOnly val="1"/>
    <c:dispBlanksAs val="gap"/>
    <c:showDLblsOverMax val="0"/>
    <c:extLst>
      <c:ext uri="{0b15fc19-7d7d-44ad-8c2d-2c3a37ce22c3}">
        <chartProps xmlns="https://web.wps.cn/et/2018/main" chartId="{d842cf60-fc7a-4cf4-836b-13cc11de8109}"/>
      </c:ext>
    </c:extLst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 lang="zh-CN" sz="1000" b="1"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 spc="20" baseline="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D73BE7-9D78-4170-82A2-1EADDB10E9C7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62451" y="1143000"/>
            <a:ext cx="4933099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04A60A-FA10-4B60-B503-2E3EB7775BA4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1143000" y="936186"/>
            <a:ext cx="6858000" cy="1991547"/>
          </a:xfrm>
        </p:spPr>
        <p:txBody>
          <a:bodyPr anchor="b"/>
          <a:lstStyle>
            <a:lvl1pPr algn="ctr">
              <a:defRPr sz="5005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004535"/>
            <a:ext cx="6858000" cy="1381105"/>
          </a:xfrm>
        </p:spPr>
        <p:txBody>
          <a:bodyPr/>
          <a:lstStyle>
            <a:lvl1pPr marL="0" indent="0" algn="ctr">
              <a:buNone/>
              <a:defRPr sz="2000"/>
            </a:lvl1pPr>
            <a:lvl2pPr marL="381635" indent="0" algn="ctr">
              <a:buNone/>
              <a:defRPr sz="1670"/>
            </a:lvl2pPr>
            <a:lvl3pPr marL="762635" indent="0" algn="ctr">
              <a:buNone/>
              <a:defRPr sz="1500"/>
            </a:lvl3pPr>
            <a:lvl4pPr marL="1144270" indent="0" algn="ctr">
              <a:buNone/>
              <a:defRPr sz="1335"/>
            </a:lvl4pPr>
            <a:lvl5pPr marL="1525270" indent="0" algn="ctr">
              <a:buNone/>
              <a:defRPr sz="1335"/>
            </a:lvl5pPr>
            <a:lvl6pPr marL="1906905" indent="0" algn="ctr">
              <a:buNone/>
              <a:defRPr sz="1335"/>
            </a:lvl6pPr>
            <a:lvl7pPr marL="2287905" indent="0" algn="ctr">
              <a:buNone/>
              <a:defRPr sz="1335"/>
            </a:lvl7pPr>
            <a:lvl8pPr marL="2669540" indent="0" algn="ctr">
              <a:buNone/>
              <a:defRPr sz="1335"/>
            </a:lvl8pPr>
            <a:lvl9pPr marL="3051175" indent="0" algn="ctr">
              <a:buNone/>
              <a:defRPr sz="1335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6543675" y="304558"/>
            <a:ext cx="1971675" cy="484777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628650" y="304558"/>
            <a:ext cx="5800725" cy="484777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623888" y="1426128"/>
            <a:ext cx="7886700" cy="2379527"/>
          </a:xfrm>
        </p:spPr>
        <p:txBody>
          <a:bodyPr anchor="b"/>
          <a:lstStyle>
            <a:lvl1pPr>
              <a:defRPr sz="5005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623888" y="3828166"/>
            <a:ext cx="7886700" cy="1251337"/>
          </a:xfrm>
        </p:spPr>
        <p:txBody>
          <a:bodyPr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381635" indent="0">
              <a:buNone/>
              <a:defRPr sz="1670">
                <a:solidFill>
                  <a:schemeClr val="tx1">
                    <a:tint val="75000"/>
                  </a:schemeClr>
                </a:solidFill>
              </a:defRPr>
            </a:lvl2pPr>
            <a:lvl3pPr marL="76263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144270" indent="0">
              <a:buNone/>
              <a:defRPr sz="1335">
                <a:solidFill>
                  <a:schemeClr val="tx1">
                    <a:tint val="75000"/>
                  </a:schemeClr>
                </a:solidFill>
              </a:defRPr>
            </a:lvl4pPr>
            <a:lvl5pPr marL="1525270" indent="0">
              <a:buNone/>
              <a:defRPr sz="1335">
                <a:solidFill>
                  <a:schemeClr val="tx1">
                    <a:tint val="75000"/>
                  </a:schemeClr>
                </a:solidFill>
              </a:defRPr>
            </a:lvl5pPr>
            <a:lvl6pPr marL="1906905" indent="0">
              <a:buNone/>
              <a:defRPr sz="1335">
                <a:solidFill>
                  <a:schemeClr val="tx1">
                    <a:tint val="75000"/>
                  </a:schemeClr>
                </a:solidFill>
              </a:defRPr>
            </a:lvl6pPr>
            <a:lvl7pPr marL="2287905" indent="0">
              <a:buNone/>
              <a:defRPr sz="1335">
                <a:solidFill>
                  <a:schemeClr val="tx1">
                    <a:tint val="75000"/>
                  </a:schemeClr>
                </a:solidFill>
              </a:defRPr>
            </a:lvl7pPr>
            <a:lvl8pPr marL="2669540" indent="0">
              <a:buNone/>
              <a:defRPr sz="1335">
                <a:solidFill>
                  <a:schemeClr val="tx1">
                    <a:tint val="75000"/>
                  </a:schemeClr>
                </a:solidFill>
              </a:defRPr>
            </a:lvl8pPr>
            <a:lvl9pPr marL="3051175" indent="0">
              <a:buNone/>
              <a:defRPr sz="13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628650" y="1522792"/>
            <a:ext cx="3886200" cy="362954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4629150" y="1522792"/>
            <a:ext cx="3886200" cy="362954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629841" y="304558"/>
            <a:ext cx="7886700" cy="110568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629841" y="1402293"/>
            <a:ext cx="3868340" cy="687242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1635" indent="0">
              <a:buNone/>
              <a:defRPr sz="1670" b="1"/>
            </a:lvl2pPr>
            <a:lvl3pPr marL="762635" indent="0">
              <a:buNone/>
              <a:defRPr sz="1500" b="1"/>
            </a:lvl3pPr>
            <a:lvl4pPr marL="1144270" indent="0">
              <a:buNone/>
              <a:defRPr sz="1335" b="1"/>
            </a:lvl4pPr>
            <a:lvl5pPr marL="1525270" indent="0">
              <a:buNone/>
              <a:defRPr sz="1335" b="1"/>
            </a:lvl5pPr>
            <a:lvl6pPr marL="1906905" indent="0">
              <a:buNone/>
              <a:defRPr sz="1335" b="1"/>
            </a:lvl6pPr>
            <a:lvl7pPr marL="2287905" indent="0">
              <a:buNone/>
              <a:defRPr sz="1335" b="1"/>
            </a:lvl7pPr>
            <a:lvl8pPr marL="2669540" indent="0">
              <a:buNone/>
              <a:defRPr sz="1335" b="1"/>
            </a:lvl8pPr>
            <a:lvl9pPr marL="3051175" indent="0">
              <a:buNone/>
              <a:defRPr sz="1335" b="1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629841" y="2089535"/>
            <a:ext cx="3868340" cy="307339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402293"/>
            <a:ext cx="3887391" cy="687242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1635" indent="0">
              <a:buNone/>
              <a:defRPr sz="1670" b="1"/>
            </a:lvl2pPr>
            <a:lvl3pPr marL="762635" indent="0">
              <a:buNone/>
              <a:defRPr sz="1500" b="1"/>
            </a:lvl3pPr>
            <a:lvl4pPr marL="1144270" indent="0">
              <a:buNone/>
              <a:defRPr sz="1335" b="1"/>
            </a:lvl4pPr>
            <a:lvl5pPr marL="1525270" indent="0">
              <a:buNone/>
              <a:defRPr sz="1335" b="1"/>
            </a:lvl5pPr>
            <a:lvl6pPr marL="1906905" indent="0">
              <a:buNone/>
              <a:defRPr sz="1335" b="1"/>
            </a:lvl6pPr>
            <a:lvl7pPr marL="2287905" indent="0">
              <a:buNone/>
              <a:defRPr sz="1335" b="1"/>
            </a:lvl7pPr>
            <a:lvl8pPr marL="2669540" indent="0">
              <a:buNone/>
              <a:defRPr sz="1335" b="1"/>
            </a:lvl8pPr>
            <a:lvl9pPr marL="3051175" indent="0">
              <a:buNone/>
              <a:defRPr sz="1335" b="1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4629150" y="2089535"/>
            <a:ext cx="3887391" cy="307339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629841" y="381360"/>
            <a:ext cx="2949178" cy="1334760"/>
          </a:xfrm>
        </p:spPr>
        <p:txBody>
          <a:bodyPr anchor="b"/>
          <a:lstStyle>
            <a:lvl1pPr>
              <a:defRPr sz="267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3887391" y="823632"/>
            <a:ext cx="4629150" cy="4065192"/>
          </a:xfrm>
        </p:spPr>
        <p:txBody>
          <a:bodyPr/>
          <a:lstStyle>
            <a:lvl1pPr>
              <a:defRPr sz="2670"/>
            </a:lvl1pPr>
            <a:lvl2pPr>
              <a:defRPr sz="2335"/>
            </a:lvl2pPr>
            <a:lvl3pPr>
              <a:defRPr sz="2000"/>
            </a:lvl3pPr>
            <a:lvl4pPr>
              <a:defRPr sz="1670"/>
            </a:lvl4pPr>
            <a:lvl5pPr>
              <a:defRPr sz="1670"/>
            </a:lvl5pPr>
            <a:lvl6pPr>
              <a:defRPr sz="1670"/>
            </a:lvl6pPr>
            <a:lvl7pPr>
              <a:defRPr sz="1670"/>
            </a:lvl7pPr>
            <a:lvl8pPr>
              <a:defRPr sz="1670"/>
            </a:lvl8pPr>
            <a:lvl9pPr>
              <a:defRPr sz="167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1716120"/>
            <a:ext cx="2949178" cy="3179325"/>
          </a:xfrm>
        </p:spPr>
        <p:txBody>
          <a:bodyPr/>
          <a:lstStyle>
            <a:lvl1pPr marL="0" indent="0">
              <a:buNone/>
              <a:defRPr sz="1335"/>
            </a:lvl1pPr>
            <a:lvl2pPr marL="381635" indent="0">
              <a:buNone/>
              <a:defRPr sz="1170"/>
            </a:lvl2pPr>
            <a:lvl3pPr marL="762635" indent="0">
              <a:buNone/>
              <a:defRPr sz="1000"/>
            </a:lvl3pPr>
            <a:lvl4pPr marL="1144270" indent="0">
              <a:buNone/>
              <a:defRPr sz="835"/>
            </a:lvl4pPr>
            <a:lvl5pPr marL="1525270" indent="0">
              <a:buNone/>
              <a:defRPr sz="835"/>
            </a:lvl5pPr>
            <a:lvl6pPr marL="1906905" indent="0">
              <a:buNone/>
              <a:defRPr sz="835"/>
            </a:lvl6pPr>
            <a:lvl7pPr marL="2287905" indent="0">
              <a:buNone/>
              <a:defRPr sz="835"/>
            </a:lvl7pPr>
            <a:lvl8pPr marL="2669540" indent="0">
              <a:buNone/>
              <a:defRPr sz="835"/>
            </a:lvl8pPr>
            <a:lvl9pPr marL="3051175" indent="0">
              <a:buNone/>
              <a:defRPr sz="835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629841" y="381360"/>
            <a:ext cx="2949178" cy="1334760"/>
          </a:xfrm>
        </p:spPr>
        <p:txBody>
          <a:bodyPr anchor="b"/>
          <a:lstStyle>
            <a:lvl1pPr>
              <a:defRPr sz="267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887391" y="823632"/>
            <a:ext cx="4629150" cy="4065192"/>
          </a:xfrm>
        </p:spPr>
        <p:txBody>
          <a:bodyPr/>
          <a:lstStyle>
            <a:lvl1pPr marL="0" indent="0">
              <a:buNone/>
              <a:defRPr sz="2670"/>
            </a:lvl1pPr>
            <a:lvl2pPr marL="381635" indent="0">
              <a:buNone/>
              <a:defRPr sz="2335"/>
            </a:lvl2pPr>
            <a:lvl3pPr marL="762635" indent="0">
              <a:buNone/>
              <a:defRPr sz="2000"/>
            </a:lvl3pPr>
            <a:lvl4pPr marL="1144270" indent="0">
              <a:buNone/>
              <a:defRPr sz="1670"/>
            </a:lvl4pPr>
            <a:lvl5pPr marL="1525270" indent="0">
              <a:buNone/>
              <a:defRPr sz="1670"/>
            </a:lvl5pPr>
            <a:lvl6pPr marL="1906905" indent="0">
              <a:buNone/>
              <a:defRPr sz="1670"/>
            </a:lvl6pPr>
            <a:lvl7pPr marL="2287905" indent="0">
              <a:buNone/>
              <a:defRPr sz="1670"/>
            </a:lvl7pPr>
            <a:lvl8pPr marL="2669540" indent="0">
              <a:buNone/>
              <a:defRPr sz="1670"/>
            </a:lvl8pPr>
            <a:lvl9pPr marL="3051175" indent="0">
              <a:buNone/>
              <a:defRPr sz="167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1716120"/>
            <a:ext cx="2949178" cy="3179325"/>
          </a:xfrm>
        </p:spPr>
        <p:txBody>
          <a:bodyPr/>
          <a:lstStyle>
            <a:lvl1pPr marL="0" indent="0">
              <a:buNone/>
              <a:defRPr sz="1335"/>
            </a:lvl1pPr>
            <a:lvl2pPr marL="381635" indent="0">
              <a:buNone/>
              <a:defRPr sz="1170"/>
            </a:lvl2pPr>
            <a:lvl3pPr marL="762635" indent="0">
              <a:buNone/>
              <a:defRPr sz="1000"/>
            </a:lvl3pPr>
            <a:lvl4pPr marL="1144270" indent="0">
              <a:buNone/>
              <a:defRPr sz="835"/>
            </a:lvl4pPr>
            <a:lvl5pPr marL="1525270" indent="0">
              <a:buNone/>
              <a:defRPr sz="835"/>
            </a:lvl5pPr>
            <a:lvl6pPr marL="1906905" indent="0">
              <a:buNone/>
              <a:defRPr sz="835"/>
            </a:lvl6pPr>
            <a:lvl7pPr marL="2287905" indent="0">
              <a:buNone/>
              <a:defRPr sz="835"/>
            </a:lvl7pPr>
            <a:lvl8pPr marL="2669540" indent="0">
              <a:buNone/>
              <a:defRPr sz="835"/>
            </a:lvl8pPr>
            <a:lvl9pPr marL="3051175" indent="0">
              <a:buNone/>
              <a:defRPr sz="835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28650" y="304558"/>
            <a:ext cx="7886700" cy="11056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8650" y="1522792"/>
            <a:ext cx="7886700" cy="36295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28650" y="5301963"/>
            <a:ext cx="2057400" cy="3045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7B5D7-BD32-46CE-A730-1DFAF153C11C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028950" y="5301963"/>
            <a:ext cx="3086100" cy="3045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457950" y="5301963"/>
            <a:ext cx="2057400" cy="3045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E6EF9-9A1D-47BF-8D4D-0AF82CA64664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62635" rtl="0" eaLnBrk="1" latinLnBrk="1" hangingPunct="1">
        <a:lnSpc>
          <a:spcPct val="90000"/>
        </a:lnSpc>
        <a:spcBef>
          <a:spcPct val="0"/>
        </a:spcBef>
        <a:buNone/>
        <a:defRPr sz="36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0500" indent="-190500" algn="l" defTabSz="762635" rtl="0" eaLnBrk="1" latinLnBrk="1" hangingPunct="1">
        <a:lnSpc>
          <a:spcPct val="90000"/>
        </a:lnSpc>
        <a:spcBef>
          <a:spcPct val="167000"/>
        </a:spcBef>
        <a:buFont typeface="Arial" panose="020B0604020202020204" pitchFamily="34" charset="0"/>
        <a:buChar char="•"/>
        <a:defRPr sz="2335" kern="1200">
          <a:solidFill>
            <a:schemeClr val="tx1"/>
          </a:solidFill>
          <a:latin typeface="+mn-lt"/>
          <a:ea typeface="+mn-ea"/>
          <a:cs typeface="+mn-cs"/>
        </a:defRPr>
      </a:lvl1pPr>
      <a:lvl2pPr marL="572135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53135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70" kern="1200">
          <a:solidFill>
            <a:schemeClr val="tx1"/>
          </a:solidFill>
          <a:latin typeface="+mn-lt"/>
          <a:ea typeface="+mn-ea"/>
          <a:cs typeface="+mn-cs"/>
        </a:defRPr>
      </a:lvl3pPr>
      <a:lvl4pPr marL="1334770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16405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97405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79040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860040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241675" indent="-190500" algn="l" defTabSz="762635" rtl="0" eaLnBrk="1" latinLnBrk="1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1635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62635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44270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5270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6905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87905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69540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51175" algn="l" defTabSz="762635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3.png"/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직사각형 58"/>
          <p:cNvSpPr/>
          <p:nvPr/>
        </p:nvSpPr>
        <p:spPr>
          <a:xfrm>
            <a:off x="482600" y="586740"/>
            <a:ext cx="524510" cy="22263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noAutofit/>
          </a:bodyPr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</a:t>
            </a:r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2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3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4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5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6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7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8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9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0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1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2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3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4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5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6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7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8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9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20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5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7398" y="4330184"/>
            <a:ext cx="4259181" cy="739583"/>
          </a:xfrm>
          <a:prstGeom prst="rect">
            <a:avLst/>
          </a:prstGeom>
        </p:spPr>
      </p:pic>
      <p:pic>
        <p:nvPicPr>
          <p:cNvPr id="6" name="그림 63" descr="F:\my experiment 1\Peanut salt\Graduation paper\SNP denisty\SNP.tif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64" t="33755" r="16623" b="41146"/>
          <a:stretch>
            <a:fillRect/>
          </a:stretch>
        </p:blipFill>
        <p:spPr bwMode="auto">
          <a:xfrm>
            <a:off x="968375" y="567055"/>
            <a:ext cx="7289165" cy="2478405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직사각형 45"/>
          <p:cNvSpPr/>
          <p:nvPr/>
        </p:nvSpPr>
        <p:spPr>
          <a:xfrm>
            <a:off x="124807" y="30259"/>
            <a:ext cx="381494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p>
            <a:r>
              <a:rPr lang="en-US" altLang="ko-KR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A)</a:t>
            </a:r>
            <a:endParaRPr lang="ko-KR" altLang="en-US" sz="10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46"/>
          <p:cNvSpPr/>
          <p:nvPr/>
        </p:nvSpPr>
        <p:spPr>
          <a:xfrm>
            <a:off x="4423206" y="24786"/>
            <a:ext cx="381494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p>
            <a:r>
              <a:rPr lang="en-US" altLang="ko-KR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B)</a:t>
            </a:r>
            <a:endParaRPr lang="ko-KR" altLang="en-US" sz="10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그림 47" descr="EMB00005a402c59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4" t="9331" b="13724"/>
          <a:stretch>
            <a:fillRect/>
          </a:stretch>
        </p:blipFill>
        <p:spPr bwMode="auto">
          <a:xfrm>
            <a:off x="643890" y="3326765"/>
            <a:ext cx="3920490" cy="1167765"/>
          </a:xfrm>
          <a:prstGeom prst="rect">
            <a:avLst/>
          </a:prstGeom>
          <a:noFill/>
        </p:spPr>
      </p:pic>
      <p:sp>
        <p:nvSpPr>
          <p:cNvPr id="14" name="직사각형 44"/>
          <p:cNvSpPr/>
          <p:nvPr/>
        </p:nvSpPr>
        <p:spPr>
          <a:xfrm>
            <a:off x="125471" y="3044122"/>
            <a:ext cx="381494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p>
            <a:r>
              <a:rPr lang="en-US" altLang="ko-KR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C)</a:t>
            </a:r>
            <a:endParaRPr lang="ko-KR" altLang="en-US" sz="10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직사각형 48"/>
          <p:cNvSpPr/>
          <p:nvPr/>
        </p:nvSpPr>
        <p:spPr>
          <a:xfrm>
            <a:off x="4423206" y="3044031"/>
            <a:ext cx="374193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p>
            <a:r>
              <a:rPr lang="en-US" altLang="ko-KR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D)</a:t>
            </a:r>
            <a:endParaRPr lang="ko-KR" altLang="en-US" sz="10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직사각형 58"/>
          <p:cNvSpPr/>
          <p:nvPr/>
        </p:nvSpPr>
        <p:spPr>
          <a:xfrm>
            <a:off x="2101850" y="3077210"/>
            <a:ext cx="934720" cy="2032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noAutofit/>
          </a:bodyPr>
          <a:p>
            <a:r>
              <a:rPr lang="en-US" altLang="ko-KR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LD decay</a:t>
            </a:r>
            <a:endParaRPr lang="en-US" altLang="ko-KR" sz="12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직사각형 59"/>
          <p:cNvSpPr/>
          <p:nvPr/>
        </p:nvSpPr>
        <p:spPr>
          <a:xfrm>
            <a:off x="1983669" y="4577326"/>
            <a:ext cx="1107794" cy="27559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p>
            <a:r>
              <a:rPr lang="en-US" altLang="ko-KR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istance (Kb)</a:t>
            </a:r>
            <a:endParaRPr lang="en-US" altLang="ko-KR" sz="12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직사각형 60"/>
          <p:cNvSpPr/>
          <p:nvPr/>
        </p:nvSpPr>
        <p:spPr>
          <a:xfrm>
            <a:off x="124758" y="3724448"/>
            <a:ext cx="428625" cy="246221"/>
          </a:xfrm>
          <a:prstGeom prst="rect">
            <a:avLst/>
          </a:prstGeom>
          <a:solidFill>
            <a:srgbClr val="000000">
              <a:alpha val="0"/>
            </a:srgbClr>
          </a:solidFill>
        </p:spPr>
        <p:txBody>
          <a:bodyPr vert="vert270" wrap="square">
            <a:spAutoFit/>
          </a:bodyPr>
          <a:p>
            <a:r>
              <a:rPr lang="en-US" altLang="ko-KR" sz="1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r</a:t>
            </a:r>
            <a:r>
              <a:rPr lang="en-US" altLang="ko-KR" sz="1600" b="1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</a:t>
            </a:r>
            <a:endParaRPr lang="en-US" altLang="ko-KR" sz="1600" b="1" baseline="30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직사각형 61"/>
          <p:cNvSpPr/>
          <p:nvPr/>
        </p:nvSpPr>
        <p:spPr>
          <a:xfrm>
            <a:off x="4564380" y="4342130"/>
            <a:ext cx="385445" cy="668020"/>
          </a:xfrm>
          <a:prstGeom prst="rect">
            <a:avLst/>
          </a:prstGeom>
          <a:solidFill>
            <a:schemeClr val="bg1"/>
          </a:solidFill>
        </p:spPr>
        <p:txBody>
          <a:bodyPr vert="vert270" wrap="square">
            <a:noAutofit/>
          </a:bodyPr>
          <a:p>
            <a:r>
              <a:rPr lang="en-US" altLang="ko-KR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Values</a:t>
            </a:r>
            <a:endParaRPr lang="ko-KR" altLang="en-US" sz="10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0" name="차트 62"/>
          <p:cNvGraphicFramePr/>
          <p:nvPr/>
        </p:nvGraphicFramePr>
        <p:xfrm>
          <a:off x="4733925" y="3072130"/>
          <a:ext cx="4321810" cy="12630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21" name="직사각형 64"/>
          <p:cNvSpPr/>
          <p:nvPr/>
        </p:nvSpPr>
        <p:spPr>
          <a:xfrm>
            <a:off x="563880" y="4420870"/>
            <a:ext cx="4169410" cy="245110"/>
          </a:xfrm>
          <a:prstGeom prst="rect">
            <a:avLst/>
          </a:prstGeom>
          <a:solidFill>
            <a:srgbClr val="000000">
              <a:alpha val="0"/>
            </a:srgbClr>
          </a:solidFill>
        </p:spPr>
        <p:txBody>
          <a:bodyPr wrap="square">
            <a:spAutoFit/>
          </a:bodyPr>
          <a:p>
            <a:r>
              <a:rPr lang="en-US" altLang="ko-KR" sz="1000" b="1" dirty="0">
                <a:solidFill>
                  <a:schemeClr val="tx1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0                50                100              150              200              </a:t>
            </a:r>
            <a:r>
              <a:rPr lang="en-US" altLang="ko-KR" sz="1000" b="1" dirty="0">
                <a:solidFill>
                  <a:srgbClr val="FF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250             </a:t>
            </a:r>
            <a:r>
              <a:rPr lang="en-US" altLang="ko-KR" sz="1000" b="1" dirty="0">
                <a:solidFill>
                  <a:schemeClr val="tx1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300   </a:t>
            </a:r>
            <a:endParaRPr lang="en-US" altLang="ko-KR" sz="1000" b="1" dirty="0">
              <a:solidFill>
                <a:schemeClr val="tx1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0" y="5074920"/>
            <a:ext cx="9144000" cy="64516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latin typeface="Times New Roman" panose="02020603050405020304"/>
                <a:ea typeface="Calibri" panose="020F0502020204030204"/>
                <a:sym typeface="+mn-ea"/>
              </a:rPr>
              <a:t>Supplementary Figure 2</a:t>
            </a:r>
            <a:r>
              <a:rPr lang="en-US" altLang="ko-KR" sz="1200" b="1">
                <a:latin typeface="Times New Roman" panose="02020603050405020304"/>
                <a:ea typeface="Times New Roman" panose="02020603050405020304"/>
              </a:rPr>
              <a:t>.</a:t>
            </a:r>
            <a:r>
              <a:rPr lang="en-US" altLang="ko-KR" sz="1200">
                <a:latin typeface="Times New Roman" panose="02020603050405020304"/>
                <a:ea typeface="Calibri" panose="020F0502020204030204"/>
              </a:rPr>
              <a:t> </a:t>
            </a:r>
            <a:r>
              <a:rPr lang="en-US" altLang="ko-KR" sz="1200">
                <a:latin typeface="Times New Roman" panose="02020603050405020304"/>
                <a:ea typeface="Times New Roman" panose="02020603050405020304"/>
              </a:rPr>
              <a:t>Genome information in the 20 chromosomes of the cultivated peanut. (A) All polymorphic SNPs; (B) Polymorphic SNPs after filter; (C) LD decay curve for LD estimation across peanut whole genome; (D) Membership probability of assigning genotypes of 295 peanut cultivated varieties to three subgroups.</a:t>
            </a:r>
            <a:r>
              <a:rPr lang="en-US" altLang="ko-KR" sz="1200">
                <a:latin typeface="Times New Roman" panose="02020603050405020304"/>
                <a:ea typeface="宋体" panose="02010600030101010101" pitchFamily="2" charset="-122"/>
              </a:rPr>
              <a:t> </a:t>
            </a:r>
            <a:endParaRPr lang="en-US" altLang="ko-KR" sz="1200">
              <a:latin typeface="Times New Roman" panose="02020603050405020304"/>
              <a:ea typeface="宋体" panose="02010600030101010101" pitchFamily="2" charset="-122"/>
            </a:endParaRPr>
          </a:p>
        </p:txBody>
      </p:sp>
      <p:sp>
        <p:nvSpPr>
          <p:cNvPr id="23" name="직사각형 58"/>
          <p:cNvSpPr/>
          <p:nvPr/>
        </p:nvSpPr>
        <p:spPr>
          <a:xfrm>
            <a:off x="755015" y="271145"/>
            <a:ext cx="3420110" cy="2032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noAutofit/>
          </a:bodyPr>
          <a:p>
            <a:pPr algn="ctr"/>
            <a:r>
              <a:rPr lang="en-US" altLang="ko-KR" sz="8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number of SNPs within 10Mb window size</a:t>
            </a:r>
            <a:endParaRPr lang="en-US" altLang="ko-KR" sz="8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0Mb     17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4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51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68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85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02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19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6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50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</a:t>
            </a:r>
            <a:endParaRPr lang="en-US" altLang="ko-KR" sz="70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4" name="직사각형 58"/>
          <p:cNvSpPr/>
          <p:nvPr/>
        </p:nvSpPr>
        <p:spPr>
          <a:xfrm>
            <a:off x="4661535" y="276225"/>
            <a:ext cx="3420110" cy="2032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noAutofit/>
          </a:bodyPr>
          <a:p>
            <a:pPr algn="ctr"/>
            <a:r>
              <a:rPr lang="en-US" altLang="ko-KR" sz="8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number of SNPs within 10Mb window size</a:t>
            </a:r>
            <a:endParaRPr lang="en-US" altLang="ko-KR" sz="8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0Mb     17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4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51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68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85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02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19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36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  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50</a:t>
            </a:r>
            <a:r>
              <a:rPr lang="en-US" altLang="ko-KR" sz="70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Mb</a:t>
            </a:r>
            <a:endParaRPr lang="en-US" altLang="ko-KR" sz="70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6" name="직사각형 58"/>
          <p:cNvSpPr/>
          <p:nvPr/>
        </p:nvSpPr>
        <p:spPr>
          <a:xfrm>
            <a:off x="4454525" y="600075"/>
            <a:ext cx="460375" cy="23526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noAutofit/>
          </a:bodyPr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</a:t>
            </a:r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2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3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4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5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6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7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8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09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0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1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2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3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4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5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6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7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8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19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r>
              <a:rPr lang="en-US" altLang="ko-KR" sz="750" b="1" dirty="0">
                <a:latin typeface="Palatino Linotype" panose="02040502050505030304" pitchFamily="18" charset="0"/>
                <a:cs typeface="Times New Roman" panose="02020603050405020304" pitchFamily="18" charset="0"/>
                <a:sym typeface="+mn-ea"/>
              </a:rPr>
              <a:t>Chr20</a:t>
            </a:r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  <a:p>
            <a:pPr algn="ctr"/>
            <a:endParaRPr lang="en-US" altLang="ko-KR" sz="750" b="1" dirty="0">
              <a:latin typeface="Palatino Linotype" panose="0204050205050503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27" name="직사각형 64"/>
          <p:cNvSpPr/>
          <p:nvPr/>
        </p:nvSpPr>
        <p:spPr>
          <a:xfrm>
            <a:off x="4804607" y="4239037"/>
            <a:ext cx="389877" cy="245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p>
            <a:endParaRPr lang="ko-KR" altLang="en-US" sz="1000" b="1" dirty="0">
              <a:solidFill>
                <a:srgbClr val="C00000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직사각형 58"/>
          <p:cNvSpPr/>
          <p:nvPr/>
        </p:nvSpPr>
        <p:spPr>
          <a:xfrm>
            <a:off x="452755" y="3271520"/>
            <a:ext cx="412750" cy="2435860"/>
          </a:xfrm>
          <a:prstGeom prst="rect">
            <a:avLst/>
          </a:prstGeom>
          <a:solidFill>
            <a:srgbClr val="000000">
              <a:alpha val="0"/>
            </a:srgbClr>
          </a:solidFill>
        </p:spPr>
        <p:txBody>
          <a:bodyPr wrap="square">
            <a:noAutofit/>
          </a:bodyPr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.6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.5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.4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.3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.2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.1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altLang="ko-KR" sz="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0</a:t>
            </a:r>
            <a:endParaRPr lang="en-US" altLang="ko-KR" sz="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ca3827a0-5679-46d4-9bb2-f1219d016ece"/>
  <p:tag name="COMMONDATA" val="eyJoZGlkIjoiZGFiYjlkYzc4N2RkMzFhNmZmMzMzZjQyN2U1ZTZhYWUifQ=="/>
  <p:tag name="commondata" val="eyJoZGlkIjoiMzA1MjdhMDExOGQ0ZjBkOTdiNGJmMzJiMjNiZTJlY2MifQ=="/>
</p:tagLst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6</Words>
  <Application>WPS 演示</Application>
  <PresentationFormat>와이드스크린</PresentationFormat>
  <Paragraphs>84</Paragraphs>
  <Slides>1</Slides>
  <Notes>16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Palatino Linotype</vt:lpstr>
      <vt:lpstr>Times New Roman</vt:lpstr>
      <vt:lpstr>Times New Roman</vt:lpstr>
      <vt:lpstr>Calibri</vt:lpstr>
      <vt:lpstr>微软雅黑</vt:lpstr>
      <vt:lpstr>Arial Unicode MS</vt:lpstr>
      <vt:lpstr>Malgun Gothic</vt:lpstr>
      <vt:lpstr>等线</vt:lpstr>
      <vt:lpstr>Office 테마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대웅</dc:creator>
  <cp:lastModifiedBy>PRESENT</cp:lastModifiedBy>
  <cp:revision>57</cp:revision>
  <dcterms:created xsi:type="dcterms:W3CDTF">2023-05-11T02:32:00Z</dcterms:created>
  <dcterms:modified xsi:type="dcterms:W3CDTF">2025-08-21T09:13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D582D5504E6471E8815E88DDC4A2B6D_13</vt:lpwstr>
  </property>
  <property fmtid="{D5CDD505-2E9C-101B-9397-08002B2CF9AE}" pid="3" name="KSOProductBuildVer">
    <vt:lpwstr>2052-12.1.0.22175</vt:lpwstr>
  </property>
</Properties>
</file>